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4737"/>
  </p:normalViewPr>
  <p:slideViewPr>
    <p:cSldViewPr snapToGrid="0" snapToObjects="1">
      <p:cViewPr varScale="1">
        <p:scale>
          <a:sx n="87" d="100"/>
          <a:sy n="87" d="100"/>
        </p:scale>
        <p:origin x="560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1ACB2A-228F-0D40-B8FC-7C1F71C89BA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5D517E0-072B-D84D-B82E-5EB3F781B63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5C196F-7C26-BB41-8C03-B66678C6D3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55CCFA-1251-0145-BA9E-E4B28027207C}" type="datetimeFigureOut">
              <a:rPr lang="en-US" smtClean="0"/>
              <a:t>10/31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BAC74F-C3C0-1E41-9A4A-E11DEC70A7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54C12E-EADE-2845-9050-EB3657BDFF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C78BD-A50E-074C-BC5A-C14D446FC5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92832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A38B14-A520-8245-9488-072E0078B8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1F48AC6-9120-6B4B-91A7-A12E403D75B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E5F0E8-9FC1-B140-833B-1ACA5FA604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55CCFA-1251-0145-BA9E-E4B28027207C}" type="datetimeFigureOut">
              <a:rPr lang="en-US" smtClean="0"/>
              <a:t>10/31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7B392D-9979-5846-8EB8-759975CE7E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E4D888-8BD6-8C44-9CAF-D799C19493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C78BD-A50E-074C-BC5A-C14D446FC5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2700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343609C-6D50-784A-BCAA-442811EF7DF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8F7B157-EFCA-3B46-AF6B-655333DD3DC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AB1CC2-1D3C-4D44-B4AF-302A49E86D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55CCFA-1251-0145-BA9E-E4B28027207C}" type="datetimeFigureOut">
              <a:rPr lang="en-US" smtClean="0"/>
              <a:t>10/31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9391D7-9B83-7949-81A0-92557DD712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2B20A8-E4C3-2D46-82DA-17F7F96C91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C78BD-A50E-074C-BC5A-C14D446FC5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398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E6F0A3-E924-A14D-B943-2474F258DA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88D76D3-8E0F-4241-B408-A9D3EA756CA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1702F4-6982-BC44-BF0E-1C05458864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55CCFA-1251-0145-BA9E-E4B28027207C}" type="datetimeFigureOut">
              <a:rPr lang="en-US" smtClean="0"/>
              <a:t>10/31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F92E1D-C4F4-0346-9C99-98D7F35CA3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34015D-9608-2345-B810-91451021DE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C78BD-A50E-074C-BC5A-C14D446FC5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37366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7B9F77-EC02-694E-BB59-3D7CC30CA3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5240F95-206E-4446-A61A-8C1529ACEA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975321-CC28-D045-BC73-995607F99D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55CCFA-1251-0145-BA9E-E4B28027207C}" type="datetimeFigureOut">
              <a:rPr lang="en-US" smtClean="0"/>
              <a:t>10/31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48820C-6A4D-B24F-85BD-D495024A16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7AFF4D-9EE2-5C44-8EC0-A3460A7B71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C78BD-A50E-074C-BC5A-C14D446FC5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24707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FB39C1-13C6-1646-A911-0402A47AE9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5C39B1B-0EC7-364B-B7E6-CAC9C57D6A4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DEC3C53-9D04-5C4F-B11A-E7BD5EE413C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8F42486-85F4-2E48-ACAB-E66411635C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55CCFA-1251-0145-BA9E-E4B28027207C}" type="datetimeFigureOut">
              <a:rPr lang="en-US" smtClean="0"/>
              <a:t>10/31/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751156D-A848-B14D-9BB0-4EE3EE251F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FF84E33-D5AD-224D-A6F0-150D7C45E7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C78BD-A50E-074C-BC5A-C14D446FC5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8713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7EDEE3-8F83-E04A-941B-8E90849E2C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BDFEF3C-E323-5542-9113-22352E86A6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10A0FD0-3B6A-8243-9E98-EFF44B984A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6F4C56F-A285-9A47-A1F3-AA2E90B5CA8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73283A0-B01F-584D-829D-72C60B59EA5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AB4E4AC-38E7-3343-A7F1-0A6DE13D70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55CCFA-1251-0145-BA9E-E4B28027207C}" type="datetimeFigureOut">
              <a:rPr lang="en-US" smtClean="0"/>
              <a:t>10/31/18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41454B3-7027-5C45-A068-70F6689C68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9640B24-3BB6-DE41-B8DE-256061EA31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C78BD-A50E-074C-BC5A-C14D446FC5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00941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DCC7DE-1D11-4E4C-82F0-51377EA43C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09E6782-7EE8-5B4E-A92B-E0EE6E9393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55CCFA-1251-0145-BA9E-E4B28027207C}" type="datetimeFigureOut">
              <a:rPr lang="en-US" smtClean="0"/>
              <a:t>10/31/18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B4A77E5-FDDF-224B-919D-5516FDC0DB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EF1CFA4-14B9-494D-8A7A-BBB52AAAA8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C78BD-A50E-074C-BC5A-C14D446FC5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65958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D92D36A-D0CC-1642-A12A-2D3D7FBC9E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55CCFA-1251-0145-BA9E-E4B28027207C}" type="datetimeFigureOut">
              <a:rPr lang="en-US" smtClean="0"/>
              <a:t>10/31/18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78928AC-CFD2-D240-9BCC-0327875B67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C6B224D-CF1F-C94A-A6E8-017947DEF4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C78BD-A50E-074C-BC5A-C14D446FC5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28762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EA1A7F-4A54-CB4F-B37D-E2CD871D69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7CEC777-E65D-044F-94E5-4D712B3EE38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F677658-13B5-2740-81A3-9B6E7ABEB88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3ED442B-4DE6-2343-9EF8-1E3383D04B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55CCFA-1251-0145-BA9E-E4B28027207C}" type="datetimeFigureOut">
              <a:rPr lang="en-US" smtClean="0"/>
              <a:t>10/31/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392BE13-4E90-BC4B-A6CB-68FA3FA127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FC02086-4D61-A14A-82CE-630AA4B310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C78BD-A50E-074C-BC5A-C14D446FC5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97852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352FC4-BA9F-7D4C-8B98-D1E08DED06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C4BDC37-ED7E-AA4F-853F-2A03F7012A1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9A27A34-9588-3144-B7B3-AFFFE5B699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1D2C044-1B67-2C44-A68E-870F2274F4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55CCFA-1251-0145-BA9E-E4B28027207C}" type="datetimeFigureOut">
              <a:rPr lang="en-US" smtClean="0"/>
              <a:t>10/31/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546907C-67C8-D243-9546-99FE720962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0998A46-CF71-8F44-AA1A-5742DB4A53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C78BD-A50E-074C-BC5A-C14D446FC5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98498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F25DC53-899A-294C-B08A-FADC40C576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BF3E169-C733-F440-BCA9-3519C89CC8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60BD30-D1D7-384F-ADBB-CBB1CD3B59E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55CCFA-1251-0145-BA9E-E4B28027207C}" type="datetimeFigureOut">
              <a:rPr lang="en-US" smtClean="0"/>
              <a:t>10/31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B41315-72E8-7A44-A774-637E8EFF698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7F8936-E881-EE46-998C-F949264EEDE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4C78BD-A50E-074C-BC5A-C14D446FC5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79331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Fatty acid beta-oxidation.pdf">
            <a:extLst>
              <a:ext uri="{FF2B5EF4-FFF2-40B4-BE49-F238E27FC236}">
                <a16:creationId xmlns:a16="http://schemas.microsoft.com/office/drawing/2014/main" id="{AB7EC85B-0182-6545-84CF-E1B198237B5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1641"/>
          <a:stretch/>
        </p:blipFill>
        <p:spPr>
          <a:xfrm>
            <a:off x="1883004" y="40597"/>
            <a:ext cx="4331971" cy="3373713"/>
          </a:xfrm>
          <a:prstGeom prst="rect">
            <a:avLst/>
          </a:prstGeom>
        </p:spPr>
      </p:pic>
      <p:pic>
        <p:nvPicPr>
          <p:cNvPr id="5" name="Picture 4" descr="Isoleucine degradation ECHS1.pdf">
            <a:extLst>
              <a:ext uri="{FF2B5EF4-FFF2-40B4-BE49-F238E27FC236}">
                <a16:creationId xmlns:a16="http://schemas.microsoft.com/office/drawing/2014/main" id="{4ED87BA0-68B0-F149-A8EB-C2FDD62E50E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3985"/>
          <a:stretch/>
        </p:blipFill>
        <p:spPr>
          <a:xfrm>
            <a:off x="1933803" y="3896228"/>
            <a:ext cx="4282771" cy="2881313"/>
          </a:xfrm>
          <a:prstGeom prst="rect">
            <a:avLst/>
          </a:prstGeom>
        </p:spPr>
      </p:pic>
      <p:pic>
        <p:nvPicPr>
          <p:cNvPr id="6" name="Picture 5" descr="Valine degradation 1.pdf">
            <a:extLst>
              <a:ext uri="{FF2B5EF4-FFF2-40B4-BE49-F238E27FC236}">
                <a16:creationId xmlns:a16="http://schemas.microsoft.com/office/drawing/2014/main" id="{8D5807C1-5085-D247-820D-43D04E6D88E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1765"/>
          <a:stretch/>
        </p:blipFill>
        <p:spPr>
          <a:xfrm>
            <a:off x="7305904" y="40597"/>
            <a:ext cx="2882900" cy="6736944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AE5B4309-6C4E-0945-890E-2FB17E586F9A}"/>
              </a:ext>
            </a:extLst>
          </p:cNvPr>
          <p:cNvSpPr txBox="1"/>
          <p:nvPr/>
        </p:nvSpPr>
        <p:spPr>
          <a:xfrm>
            <a:off x="1933803" y="403728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C04639C-3A80-7845-A903-61065DDAFB0A}"/>
              </a:ext>
            </a:extLst>
          </p:cNvPr>
          <p:cNvSpPr txBox="1"/>
          <p:nvPr/>
        </p:nvSpPr>
        <p:spPr>
          <a:xfrm>
            <a:off x="1939126" y="3470603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9CD79A6-1831-6D4F-B88B-1BF888F68D18}"/>
              </a:ext>
            </a:extLst>
          </p:cNvPr>
          <p:cNvSpPr txBox="1"/>
          <p:nvPr/>
        </p:nvSpPr>
        <p:spPr>
          <a:xfrm>
            <a:off x="6593975" y="403728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8A399A4D-DE27-ED40-87A6-CFED8871B5FA}"/>
              </a:ext>
            </a:extLst>
          </p:cNvPr>
          <p:cNvCxnSpPr/>
          <p:nvPr/>
        </p:nvCxnSpPr>
        <p:spPr>
          <a:xfrm rot="10800000" flipV="1">
            <a:off x="3902304" y="3172328"/>
            <a:ext cx="279400" cy="1"/>
          </a:xfrm>
          <a:prstGeom prst="straightConnector1">
            <a:avLst/>
          </a:prstGeom>
          <a:ln w="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F655CA51-D4D5-D54A-897F-0BE36F4AA6AA}"/>
              </a:ext>
            </a:extLst>
          </p:cNvPr>
          <p:cNvCxnSpPr/>
          <p:nvPr/>
        </p:nvCxnSpPr>
        <p:spPr>
          <a:xfrm>
            <a:off x="3038706" y="3185028"/>
            <a:ext cx="228599" cy="1"/>
          </a:xfrm>
          <a:prstGeom prst="straightConnector1">
            <a:avLst/>
          </a:prstGeom>
          <a:ln w="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D46A008F-6A8B-C542-AB50-2EF0378B7195}"/>
              </a:ext>
            </a:extLst>
          </p:cNvPr>
          <p:cNvCxnSpPr/>
          <p:nvPr/>
        </p:nvCxnSpPr>
        <p:spPr>
          <a:xfrm rot="10800000" flipV="1">
            <a:off x="9566504" y="5896651"/>
            <a:ext cx="279400" cy="1"/>
          </a:xfrm>
          <a:prstGeom prst="straightConnector1">
            <a:avLst/>
          </a:prstGeom>
          <a:ln w="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187D5D0A-D52C-244A-B9EE-153D5F1EB8DA}"/>
              </a:ext>
            </a:extLst>
          </p:cNvPr>
          <p:cNvCxnSpPr/>
          <p:nvPr/>
        </p:nvCxnSpPr>
        <p:spPr>
          <a:xfrm>
            <a:off x="7813904" y="6274567"/>
            <a:ext cx="215899" cy="1588"/>
          </a:xfrm>
          <a:prstGeom prst="straightConnector1">
            <a:avLst/>
          </a:prstGeom>
          <a:ln w="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209672E6-F3EA-284C-A5FC-2E2D89A55033}"/>
              </a:ext>
            </a:extLst>
          </p:cNvPr>
          <p:cNvCxnSpPr/>
          <p:nvPr/>
        </p:nvCxnSpPr>
        <p:spPr>
          <a:xfrm rot="10800000" flipV="1">
            <a:off x="8423503" y="6125253"/>
            <a:ext cx="279400" cy="1"/>
          </a:xfrm>
          <a:prstGeom prst="straightConnector1">
            <a:avLst/>
          </a:prstGeom>
          <a:ln w="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926AE215-6C7E-1243-BFAE-A931AF647D70}"/>
              </a:ext>
            </a:extLst>
          </p:cNvPr>
          <p:cNvCxnSpPr/>
          <p:nvPr/>
        </p:nvCxnSpPr>
        <p:spPr>
          <a:xfrm rot="10800000" flipV="1">
            <a:off x="2899004" y="6328455"/>
            <a:ext cx="279400" cy="1"/>
          </a:xfrm>
          <a:prstGeom prst="straightConnector1">
            <a:avLst/>
          </a:prstGeom>
          <a:ln w="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CEF41D39-694B-D144-BB9F-4C8C64BD76B7}"/>
              </a:ext>
            </a:extLst>
          </p:cNvPr>
          <p:cNvCxnSpPr/>
          <p:nvPr/>
        </p:nvCxnSpPr>
        <p:spPr>
          <a:xfrm>
            <a:off x="2252032" y="6574341"/>
            <a:ext cx="215899" cy="1588"/>
          </a:xfrm>
          <a:prstGeom prst="straightConnector1">
            <a:avLst/>
          </a:prstGeom>
          <a:ln w="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76D4AC3F-050A-7741-A7E4-4C8C369536F6}"/>
              </a:ext>
            </a:extLst>
          </p:cNvPr>
          <p:cNvCxnSpPr/>
          <p:nvPr/>
        </p:nvCxnSpPr>
        <p:spPr>
          <a:xfrm>
            <a:off x="8931503" y="6290355"/>
            <a:ext cx="215899" cy="1588"/>
          </a:xfrm>
          <a:prstGeom prst="straightConnector1">
            <a:avLst/>
          </a:prstGeom>
          <a:ln w="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1F5A42B9-548E-BF45-BA5A-C5F01A4E7975}"/>
              </a:ext>
            </a:extLst>
          </p:cNvPr>
          <p:cNvCxnSpPr/>
          <p:nvPr/>
        </p:nvCxnSpPr>
        <p:spPr>
          <a:xfrm>
            <a:off x="2702154" y="5742664"/>
            <a:ext cx="215899" cy="1588"/>
          </a:xfrm>
          <a:prstGeom prst="straightConnector1">
            <a:avLst/>
          </a:prstGeom>
          <a:ln w="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61CFCA8C-E006-434D-9F35-14B438ACABC7}"/>
              </a:ext>
            </a:extLst>
          </p:cNvPr>
          <p:cNvCxnSpPr/>
          <p:nvPr/>
        </p:nvCxnSpPr>
        <p:spPr>
          <a:xfrm>
            <a:off x="2182182" y="1597528"/>
            <a:ext cx="215899" cy="1588"/>
          </a:xfrm>
          <a:prstGeom prst="straightConnector1">
            <a:avLst/>
          </a:prstGeom>
          <a:ln w="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5414ACED-7298-E945-A9AF-EB35C7D5D665}"/>
              </a:ext>
            </a:extLst>
          </p:cNvPr>
          <p:cNvCxnSpPr/>
          <p:nvPr/>
        </p:nvCxnSpPr>
        <p:spPr>
          <a:xfrm rot="10800000" flipV="1">
            <a:off x="2841853" y="2105528"/>
            <a:ext cx="279400" cy="1"/>
          </a:xfrm>
          <a:prstGeom prst="straightConnector1">
            <a:avLst/>
          </a:prstGeom>
          <a:ln w="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69579199-0757-D946-BA73-FF2BB8CAB114}"/>
              </a:ext>
            </a:extLst>
          </p:cNvPr>
          <p:cNvCxnSpPr/>
          <p:nvPr/>
        </p:nvCxnSpPr>
        <p:spPr>
          <a:xfrm rot="10800000" flipV="1">
            <a:off x="9553802" y="5615663"/>
            <a:ext cx="279400" cy="1"/>
          </a:xfrm>
          <a:prstGeom prst="straightConnector1">
            <a:avLst/>
          </a:prstGeom>
          <a:ln w="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B711D71B-D899-3849-B707-F7FA267490F9}"/>
              </a:ext>
            </a:extLst>
          </p:cNvPr>
          <p:cNvCxnSpPr/>
          <p:nvPr/>
        </p:nvCxnSpPr>
        <p:spPr>
          <a:xfrm rot="10800000" flipV="1">
            <a:off x="9579203" y="6125255"/>
            <a:ext cx="279400" cy="1"/>
          </a:xfrm>
          <a:prstGeom prst="straightConnector1">
            <a:avLst/>
          </a:prstGeom>
          <a:ln w="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E41405A9-ED4F-8F40-B282-9A9B4B6D12E0}"/>
              </a:ext>
            </a:extLst>
          </p:cNvPr>
          <p:cNvCxnSpPr/>
          <p:nvPr/>
        </p:nvCxnSpPr>
        <p:spPr>
          <a:xfrm>
            <a:off x="3292705" y="5756952"/>
            <a:ext cx="215899" cy="1588"/>
          </a:xfrm>
          <a:prstGeom prst="straightConnector1">
            <a:avLst/>
          </a:prstGeom>
          <a:ln w="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C404D6DE-09B4-F54D-9EC8-47834203CBC2}"/>
              </a:ext>
            </a:extLst>
          </p:cNvPr>
          <p:cNvCxnSpPr/>
          <p:nvPr/>
        </p:nvCxnSpPr>
        <p:spPr>
          <a:xfrm rot="10800000" flipV="1">
            <a:off x="8982301" y="3827234"/>
            <a:ext cx="279400" cy="1"/>
          </a:xfrm>
          <a:prstGeom prst="straightConnector1">
            <a:avLst/>
          </a:prstGeom>
          <a:ln w="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37B46398-7769-804E-B52B-847514211CF3}"/>
              </a:ext>
            </a:extLst>
          </p:cNvPr>
          <p:cNvCxnSpPr/>
          <p:nvPr/>
        </p:nvCxnSpPr>
        <p:spPr>
          <a:xfrm rot="10800000" flipV="1">
            <a:off x="8995001" y="4302626"/>
            <a:ext cx="279400" cy="1"/>
          </a:xfrm>
          <a:prstGeom prst="straightConnector1">
            <a:avLst/>
          </a:prstGeom>
          <a:ln w="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C1EE0415-C3D6-C442-88F7-EBC5879BAB33}"/>
              </a:ext>
            </a:extLst>
          </p:cNvPr>
          <p:cNvCxnSpPr/>
          <p:nvPr/>
        </p:nvCxnSpPr>
        <p:spPr>
          <a:xfrm rot="10800000" flipV="1">
            <a:off x="9007702" y="4683626"/>
            <a:ext cx="279400" cy="1"/>
          </a:xfrm>
          <a:prstGeom prst="straightConnector1">
            <a:avLst/>
          </a:prstGeom>
          <a:ln w="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7C42C2AD-43CF-A04B-9A50-6643AE3CD93B}"/>
              </a:ext>
            </a:extLst>
          </p:cNvPr>
          <p:cNvCxnSpPr/>
          <p:nvPr/>
        </p:nvCxnSpPr>
        <p:spPr>
          <a:xfrm rot="10800000" flipV="1">
            <a:off x="9007702" y="5126539"/>
            <a:ext cx="279400" cy="1"/>
          </a:xfrm>
          <a:prstGeom prst="straightConnector1">
            <a:avLst/>
          </a:prstGeom>
          <a:ln w="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5ECB3EE2-37F6-F042-9B79-6CEF67F3EB06}"/>
              </a:ext>
            </a:extLst>
          </p:cNvPr>
          <p:cNvSpPr txBox="1"/>
          <p:nvPr/>
        </p:nvSpPr>
        <p:spPr>
          <a:xfrm>
            <a:off x="4567125" y="5962618"/>
            <a:ext cx="2300630" cy="7848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Key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: Arrows in black: products</a:t>
            </a: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rrows within pathways: Flow of catalysis</a:t>
            </a: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Diamond shapes: Complexes</a:t>
            </a: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Genes in purple: upregulated</a:t>
            </a: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Genes in green: downregulated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33DD6070-A954-C94A-8C2C-74435FD17FF8}"/>
              </a:ext>
            </a:extLst>
          </p:cNvPr>
          <p:cNvSpPr txBox="1"/>
          <p:nvPr/>
        </p:nvSpPr>
        <p:spPr>
          <a:xfrm>
            <a:off x="0" y="0"/>
            <a:ext cx="136287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dditional Figure 4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26362604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4</Words>
  <Application>Microsoft Macintosh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1</cp:revision>
  <dcterms:created xsi:type="dcterms:W3CDTF">2018-11-01T03:09:59Z</dcterms:created>
  <dcterms:modified xsi:type="dcterms:W3CDTF">2018-11-01T03:10:32Z</dcterms:modified>
</cp:coreProperties>
</file>